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A7BD74-79A1-48B4-857F-3BBE9601D2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0F94C2B-93E0-4852-B70D-468F3151D7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1D084B-7CEF-457A-B219-EF40125CD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C6E609-78D2-43FD-A85A-C9A575B4A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747891-22B3-45BA-B036-4A14CA747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0470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8CC820-7CCC-41B3-AC33-430772213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F61C68B-555E-481E-964B-C0D8BE767E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77B464A-6EDC-4DC9-BD18-008AEC19D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8CCBAC1-7ADC-46D6-BE3C-127C3BEF0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3659FE-9B09-46D5-9663-B0A27EF2E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4259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55DD1A8-C75F-4968-B1B7-CCE13DE3BF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F1BF0F-D33B-4B83-97AB-20F7BB83AD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6E670B3-5D3F-4B2B-B15A-236917045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81631A-E9D8-42A6-BD84-CD5C1DF44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BABFFC5-F7E9-4DF6-8748-F7EBEB41D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5508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15B724-6CE2-49D7-9110-6E665B3156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88A435A-1009-4C74-B382-ED221B9B67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351F888-705E-4E35-BD86-618D49129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2A6BAA2-5547-4FBE-AB4D-2910257B2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9E5B5B1-8317-483A-A4C4-759DD6174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3709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391550-19A6-424A-9F1F-E2C532016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C120823-83E4-467C-814E-315FB604B3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954BF5-005E-4B0D-B7E5-B207EE131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EB9ADF-75A6-4892-B114-A6171C3E0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5BBDCE8-DB6A-4885-8489-EC4448252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2267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06E19D-6069-44C5-8180-B5385AA655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35260F5-D0B0-49A6-A6EF-64FC5E32C7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CAA24BF-48C0-4565-A502-29C1071879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54C7AD4-21CF-4129-BE39-C118B55C8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410CFF9-ECE0-4A70-9AB4-5A1EB276F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BCA015A-3E39-458E-A679-184395D09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5876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850153-CB36-48DD-9B7D-C754F399EA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8B87B31-861C-4C3F-B78B-8EF7B678FD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D6D63B0-6D00-4F8C-BD70-8D525E815C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4CA3EEF-FF19-4DEF-85B8-76AD461161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D94F7D7-B167-4300-B731-5ACD6EFAE6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B15D268-20BC-46EC-971A-11706A862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5FA172E-0D3A-4CF6-B428-8DD4345B1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C48DACB-BA84-4E40-9CE7-ED8D26390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9518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4903D2D-6701-45BF-A4AA-291861396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B555E13-311F-4D61-B785-9E91505D0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74C8B7B-313F-4D5F-9E6B-3158D9ED5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4683C30-9AB4-4400-A8A3-C8440A71D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2237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16E3988-13B3-4F84-A93A-0701760AA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9C644C7-0458-475A-9A40-17BB8C0D7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435E4EE-0AA5-4929-BFF9-6093BD983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2139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8D8934-75DC-4D88-BCE7-A5460C498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5A0A66C-07D2-4FA1-A4AA-48E8A6FCAD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72ED455-17B8-4859-BD1F-75FAADEFA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61C247A-0F6F-416D-8A8A-E8F9DE0AC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CD7F1AD-A15B-4386-8502-59E72AB13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286051D-AEE4-4EE6-837F-EB4D6CA52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1888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F483BE-D2F3-40E8-AF09-30302D709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D2BF5CA-A1BE-48FE-98FA-6590379042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ED3A121-1812-4065-8E75-D7BD5E7D71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A6173B6-CC01-4827-A206-18A4D7756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107EAAD-A9D0-4FDE-B8A5-D245F0BBB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8D44EB1-F876-4AE1-84FB-B5244E361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666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AA4E0EE-F7CD-401C-81AC-56DC52F20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DECFE6C-C6BD-4180-A307-182EC60326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42EAA71-A710-466E-8256-966B2D587F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E568C-EC50-4BF7-A2A8-D7AB71D2EC65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600B98-2167-4419-8AD0-229FCD6689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264E69B-16F3-497A-8BA4-085A18E07F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0CE58-2468-4247-83C2-CDBC721F36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637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5104543B-D76C-484A-AA11-916FFEC40C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465722"/>
              </p:ext>
            </p:extLst>
          </p:nvPr>
        </p:nvGraphicFramePr>
        <p:xfrm>
          <a:off x="3397250" y="1431319"/>
          <a:ext cx="5729287" cy="2583180"/>
        </p:xfrm>
        <a:graphic>
          <a:graphicData uri="http://schemas.openxmlformats.org/drawingml/2006/table">
            <a:tbl>
              <a:tblPr/>
              <a:tblGrid>
                <a:gridCol w="1422400">
                  <a:extLst>
                    <a:ext uri="{9D8B030D-6E8A-4147-A177-3AD203B41FA5}">
                      <a16:colId xmlns:a16="http://schemas.microsoft.com/office/drawing/2014/main" val="3836626750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99505487"/>
                    </a:ext>
                  </a:extLst>
                </a:gridCol>
                <a:gridCol w="1411287">
                  <a:extLst>
                    <a:ext uri="{9D8B030D-6E8A-4147-A177-3AD203B41FA5}">
                      <a16:colId xmlns:a16="http://schemas.microsoft.com/office/drawing/2014/main" val="2433279239"/>
                    </a:ext>
                  </a:extLst>
                </a:gridCol>
                <a:gridCol w="1079500">
                  <a:extLst>
                    <a:ext uri="{9D8B030D-6E8A-4147-A177-3AD203B41FA5}">
                      <a16:colId xmlns:a16="http://schemas.microsoft.com/office/drawing/2014/main" val="1615636364"/>
                    </a:ext>
                  </a:extLst>
                </a:gridCol>
                <a:gridCol w="736600">
                  <a:extLst>
                    <a:ext uri="{9D8B030D-6E8A-4147-A177-3AD203B41FA5}">
                      <a16:colId xmlns:a16="http://schemas.microsoft.com/office/drawing/2014/main" val="463662370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gor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Δ met criteria (n=56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 all Δ met criteria (n=8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(n=64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5349049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I (kg/m</a:t>
                      </a:r>
                      <a:r>
                        <a:rPr lang="de-DE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20863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≥18.5-24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(39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(40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248122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0-2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43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(44.7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67709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-34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7.1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4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99314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774182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state volume (cc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52482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2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2.5%)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0.9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107605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-5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 (46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75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 (5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66316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-8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35.7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25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 (34.4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542193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0-119.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6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256081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≥1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.8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.6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98157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7484303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947507E6-AF73-4EF0-B28B-2632F9205D16}"/>
              </a:ext>
            </a:extLst>
          </p:cNvPr>
          <p:cNvSpPr txBox="1"/>
          <p:nvPr/>
        </p:nvSpPr>
        <p:spPr>
          <a:xfrm>
            <a:off x="3263900" y="4182806"/>
            <a:ext cx="553085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/>
              <a:t>Table </a:t>
            </a:r>
            <a:r>
              <a:rPr lang="de-DE" sz="1100" b="1" smtClean="0"/>
              <a:t>2. </a:t>
            </a:r>
            <a:r>
              <a:rPr lang="de-DE" sz="1100" b="1" dirty="0"/>
              <a:t>All DRR </a:t>
            </a:r>
            <a:r>
              <a:rPr lang="de-DE" sz="1100" b="1" dirty="0" err="1"/>
              <a:t>triangles</a:t>
            </a:r>
            <a:r>
              <a:rPr lang="de-DE" sz="1100" b="1" dirty="0"/>
              <a:t> vs. not all DRR </a:t>
            </a:r>
            <a:r>
              <a:rPr lang="de-DE" sz="1100" b="1" dirty="0" err="1"/>
              <a:t>triangles</a:t>
            </a:r>
            <a:r>
              <a:rPr lang="de-DE" sz="1100" b="1" dirty="0"/>
              <a:t> </a:t>
            </a:r>
            <a:r>
              <a:rPr lang="de-DE" sz="1100" b="1" dirty="0" err="1"/>
              <a:t>detected</a:t>
            </a:r>
            <a:r>
              <a:rPr lang="de-DE" sz="1100" b="1" dirty="0"/>
              <a:t> in </a:t>
            </a:r>
            <a:r>
              <a:rPr lang="de-DE" sz="1100" b="1" dirty="0" err="1"/>
              <a:t>dependance</a:t>
            </a:r>
            <a:r>
              <a:rPr lang="de-DE" sz="1100" b="1" dirty="0"/>
              <a:t> of BMI- and </a:t>
            </a:r>
            <a:r>
              <a:rPr lang="de-DE" sz="1100" b="1" dirty="0" err="1"/>
              <a:t>prostate</a:t>
            </a:r>
            <a:r>
              <a:rPr lang="de-DE" sz="1100" b="1" dirty="0"/>
              <a:t> </a:t>
            </a:r>
            <a:r>
              <a:rPr lang="de-DE" sz="1100" b="1" dirty="0" err="1"/>
              <a:t>volume</a:t>
            </a:r>
            <a:r>
              <a:rPr lang="de-DE" sz="1100" b="1" dirty="0"/>
              <a:t>-groups. </a:t>
            </a:r>
            <a:r>
              <a:rPr lang="de-DE" sz="1100" dirty="0"/>
              <a:t>N = the </a:t>
            </a:r>
            <a:r>
              <a:rPr lang="de-DE" sz="1100" dirty="0" err="1"/>
              <a:t>whole</a:t>
            </a:r>
            <a:r>
              <a:rPr lang="de-DE" sz="1100" dirty="0"/>
              <a:t> </a:t>
            </a:r>
            <a:r>
              <a:rPr lang="de-DE" sz="1100" dirty="0" err="1"/>
              <a:t>cohort</a:t>
            </a:r>
            <a:r>
              <a:rPr lang="de-DE" sz="1100" dirty="0"/>
              <a:t> (64). The BMI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according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the </a:t>
            </a:r>
            <a:r>
              <a:rPr lang="de-DE" sz="1100" dirty="0" err="1"/>
              <a:t>official</a:t>
            </a:r>
            <a:r>
              <a:rPr lang="de-DE" sz="1100" dirty="0"/>
              <a:t> BMI </a:t>
            </a:r>
            <a:r>
              <a:rPr lang="de-DE" sz="1100" dirty="0" err="1"/>
              <a:t>classification</a:t>
            </a:r>
            <a:r>
              <a:rPr lang="de-DE" sz="1100" dirty="0"/>
              <a:t>. The </a:t>
            </a:r>
            <a:r>
              <a:rPr lang="de-DE" sz="1100" dirty="0" err="1"/>
              <a:t>volume</a:t>
            </a:r>
            <a:r>
              <a:rPr lang="de-DE" sz="1100" dirty="0"/>
              <a:t>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starting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a normal </a:t>
            </a:r>
            <a:r>
              <a:rPr lang="de-DE" sz="1100" dirty="0" err="1"/>
              <a:t>volume</a:t>
            </a:r>
            <a:r>
              <a:rPr lang="de-DE" sz="1100" dirty="0"/>
              <a:t> of </a:t>
            </a:r>
            <a:r>
              <a:rPr lang="de-DE" sz="1100" dirty="0" err="1"/>
              <a:t>up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30 ml and </a:t>
            </a:r>
            <a:r>
              <a:rPr lang="de-DE" sz="1100" dirty="0" err="1"/>
              <a:t>then</a:t>
            </a:r>
            <a:r>
              <a:rPr lang="de-DE" sz="1100" dirty="0"/>
              <a:t> </a:t>
            </a:r>
            <a:r>
              <a:rPr lang="de-DE" sz="1100" dirty="0" err="1"/>
              <a:t>proceding</a:t>
            </a:r>
            <a:r>
              <a:rPr lang="de-DE" sz="1100" dirty="0"/>
              <a:t> in 30 ml </a:t>
            </a:r>
            <a:r>
              <a:rPr lang="de-DE" sz="1100" dirty="0" err="1"/>
              <a:t>steps</a:t>
            </a:r>
            <a:r>
              <a:rPr lang="de-DE" sz="1100" dirty="0"/>
              <a:t>. There was </a:t>
            </a:r>
            <a:r>
              <a:rPr lang="de-DE" sz="1100" dirty="0" err="1"/>
              <a:t>no</a:t>
            </a:r>
            <a:r>
              <a:rPr lang="de-DE" sz="1100" dirty="0"/>
              <a:t> </a:t>
            </a:r>
            <a:r>
              <a:rPr lang="de-DE" sz="1100" dirty="0" err="1"/>
              <a:t>significant</a:t>
            </a:r>
            <a:r>
              <a:rPr lang="de-DE" sz="1100" dirty="0"/>
              <a:t>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although</a:t>
            </a:r>
            <a:r>
              <a:rPr lang="de-DE" sz="1100" dirty="0"/>
              <a:t> </a:t>
            </a:r>
            <a:r>
              <a:rPr lang="de-DE" sz="1100" dirty="0" err="1"/>
              <a:t>there</a:t>
            </a:r>
            <a:r>
              <a:rPr lang="de-DE" sz="1100" dirty="0"/>
              <a:t> </a:t>
            </a:r>
            <a:r>
              <a:rPr lang="de-DE" sz="1100" dirty="0" err="1"/>
              <a:t>seemed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be</a:t>
            </a:r>
            <a:r>
              <a:rPr lang="de-DE" sz="1100" dirty="0"/>
              <a:t> a negative </a:t>
            </a:r>
            <a:r>
              <a:rPr lang="de-DE" sz="1100" dirty="0" err="1"/>
              <a:t>impact</a:t>
            </a:r>
            <a:r>
              <a:rPr lang="de-DE" sz="1100" dirty="0"/>
              <a:t> on </a:t>
            </a:r>
            <a:r>
              <a:rPr lang="de-DE" sz="1100" dirty="0" err="1"/>
              <a:t>detectability</a:t>
            </a:r>
            <a:r>
              <a:rPr lang="de-DE" sz="1100" dirty="0"/>
              <a:t> in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very</a:t>
            </a:r>
            <a:r>
              <a:rPr lang="de-DE" sz="1100" dirty="0"/>
              <a:t> </a:t>
            </a:r>
            <a:r>
              <a:rPr lang="de-DE" sz="1100" dirty="0" err="1"/>
              <a:t>small</a:t>
            </a:r>
            <a:r>
              <a:rPr lang="de-DE" sz="1100" dirty="0"/>
              <a:t> and </a:t>
            </a:r>
            <a:r>
              <a:rPr lang="de-DE" sz="1100" dirty="0" err="1"/>
              <a:t>very</a:t>
            </a:r>
            <a:r>
              <a:rPr lang="de-DE" sz="1100" dirty="0"/>
              <a:t> large </a:t>
            </a:r>
            <a:r>
              <a:rPr lang="de-DE" sz="1100" dirty="0" err="1"/>
              <a:t>glands</a:t>
            </a:r>
            <a:r>
              <a:rPr lang="de-DE" sz="11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909888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BF902BE9-532A-444C-97EA-2FD4B6CD230F}"/>
              </a:ext>
            </a:extLst>
          </p:cNvPr>
          <p:cNvSpPr/>
          <p:nvPr/>
        </p:nvSpPr>
        <p:spPr>
          <a:xfrm>
            <a:off x="3048000" y="857238"/>
            <a:ext cx="6096000" cy="51435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Implant Geometry and Detection Rates of Prostate Fiducial Markers after Trans-Rectal-Ultrasound-Guided Perineal Implantation for Image-Guided 6D-Tracking Robotic Stereotactic Body Radiotherap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Strahlentherap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u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Onkolog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Katharina Heil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aniel Zips, Goda Kalinauskaite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Dirk Boehmer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Corresponding Author: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MD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epartment for Radiation Oncology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</a:rPr>
              <a:t>–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Universitaetsmedizin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orporate member of Freie Universitaet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</a:rPr>
              <a:t>Humboldt-Universitaet zu Berlin and Berlin Institute of Health</a:t>
            </a: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Campus Virchow-Klinikum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ugustenburger Platz 1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13353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German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Tel: 0049-30-450-6272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Fax: 0049-30-450-7527152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Email: </a:t>
            </a: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arne.gruen@charite.d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ORCID: 0000-0002-3868-27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797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6</Words>
  <Application>Microsoft Office PowerPoint</Application>
  <PresentationFormat>Breitbild</PresentationFormat>
  <Paragraphs>8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ün, Arne</dc:creator>
  <cp:lastModifiedBy>A</cp:lastModifiedBy>
  <cp:revision>12</cp:revision>
  <dcterms:created xsi:type="dcterms:W3CDTF">2024-08-03T08:29:47Z</dcterms:created>
  <dcterms:modified xsi:type="dcterms:W3CDTF">2025-01-05T13:57:52Z</dcterms:modified>
</cp:coreProperties>
</file>